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5266"/>
    <p:restoredTop sz="94696"/>
  </p:normalViewPr>
  <p:slideViewPr>
    <p:cSldViewPr snapToGrid="0">
      <p:cViewPr varScale="1">
        <p:scale>
          <a:sx n="98" d="100"/>
          <a:sy n="98" d="100"/>
        </p:scale>
        <p:origin x="75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E889BC-9A68-D1F9-A199-4E0D6911300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756979E-A227-2DA5-219F-BD70F0BD95F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5EB707-F88E-E840-FE76-CF83DE794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8BCA0-4444-2247-9867-5C255DEC7E0B}" type="datetimeFigureOut">
              <a:rPr lang="en-SE" smtClean="0"/>
              <a:t>10/11/2024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BB32DE-B90A-9293-C928-972F417FB0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8657D0-E5B4-92A1-5FA6-D5E5483E4E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C95F9-F8F9-5B4A-BF3B-32E7657CC304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4338384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F81882-AB63-89D6-170E-B3904C04C5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E8A048-AE17-F70B-2097-29C17CF739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16C7F1-07E8-377B-70B8-FD97AFA440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8BCA0-4444-2247-9867-5C255DEC7E0B}" type="datetimeFigureOut">
              <a:rPr lang="en-SE" smtClean="0"/>
              <a:t>10/11/2024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D4AF3B-78BB-1A9F-38B1-F976DE7A09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638CCB-FAAC-2581-A75A-62BBB496C5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C95F9-F8F9-5B4A-BF3B-32E7657CC304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460802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3331AD1-393D-4455-B5AD-A6E8DCF9BB0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78863E-5CB8-5724-9565-70AD4DE2FF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07FA90-6C50-E18A-A1EC-C8C69E85DE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8BCA0-4444-2247-9867-5C255DEC7E0B}" type="datetimeFigureOut">
              <a:rPr lang="en-SE" smtClean="0"/>
              <a:t>10/11/2024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F21215-0FF5-7D45-5E6E-2058B6CBD7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B7AD0C-2CE2-DF07-B90D-4E48C9DAA0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C95F9-F8F9-5B4A-BF3B-32E7657CC304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7652889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B29853-C564-D214-98E0-044FD2F095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41AA66-6F78-290E-8280-D517952D26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87C975-2824-9C1C-5BE9-272838A17B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8BCA0-4444-2247-9867-5C255DEC7E0B}" type="datetimeFigureOut">
              <a:rPr lang="en-SE" smtClean="0"/>
              <a:t>10/11/2024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FCD483-7BE1-86F1-BC9D-8B6918E93C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2E40D5-EE81-C643-4B1C-951443B9D3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C95F9-F8F9-5B4A-BF3B-32E7657CC304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6284193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1BC1C5-7553-27D1-EDE9-F45AFFD780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B38C59-5C81-8CB6-F7FE-36E3F62A00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28D300-7336-73EC-3597-72E2C346B3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8BCA0-4444-2247-9867-5C255DEC7E0B}" type="datetimeFigureOut">
              <a:rPr lang="en-SE" smtClean="0"/>
              <a:t>10/11/2024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A8EACB-B34E-5DCD-4989-CAA8CB36EE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2151EC-DE5A-190B-1822-F747DAC28D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C95F9-F8F9-5B4A-BF3B-32E7657CC304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115198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32A5D3-6CF4-6A67-EAA5-ABC53F1002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7E6925-9570-4C37-7AB9-179D6F8D35C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970CD7-7F0B-60C5-A4FA-547E26B146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0B1F20-B14A-4F15-5C24-CB67C20889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8BCA0-4444-2247-9867-5C255DEC7E0B}" type="datetimeFigureOut">
              <a:rPr lang="en-SE" smtClean="0"/>
              <a:t>10/11/2024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8B3273E-A7B9-EB4B-4D60-FBEE7C7C60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556F5F-A50F-4ED7-D58E-40DBFF7946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C95F9-F8F9-5B4A-BF3B-32E7657CC304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613529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DE966D-5D51-BD2D-353A-C4027F4FB3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EA59405-927D-5563-C966-5471200C4C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12E84AB-D403-1B22-9A05-CD2F3D0663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F5004F7-3ADB-16EF-2D87-808D5A65AD3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6BEE8AA-FBA1-6EA8-3E2D-DB244A8406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4421824-1EDF-D0C9-3720-D07776A2A4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8BCA0-4444-2247-9867-5C255DEC7E0B}" type="datetimeFigureOut">
              <a:rPr lang="en-SE" smtClean="0"/>
              <a:t>10/11/2024</a:t>
            </a:fld>
            <a:endParaRPr lang="en-S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C7089C1-F762-8CCC-21D4-06186F2D9C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57C9616-8C74-9915-2F78-81AE108BD6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C95F9-F8F9-5B4A-BF3B-32E7657CC304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0245301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E356B6-C6B6-C9B3-18A2-6FD9F0A19D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E666B8A-3B2F-4B2E-E867-9110ACDC31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8BCA0-4444-2247-9867-5C255DEC7E0B}" type="datetimeFigureOut">
              <a:rPr lang="en-SE" smtClean="0"/>
              <a:t>10/11/2024</a:t>
            </a:fld>
            <a:endParaRPr lang="en-S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7AA6CCD-CF06-36D2-E553-3F820998E5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2D8BCFF-CEC6-7CB3-9134-2C565F4DFC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C95F9-F8F9-5B4A-BF3B-32E7657CC304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4486113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AD19EFE-8B94-FA1C-8AFF-A3E44375EE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8BCA0-4444-2247-9867-5C255DEC7E0B}" type="datetimeFigureOut">
              <a:rPr lang="en-SE" smtClean="0"/>
              <a:t>10/11/2024</a:t>
            </a:fld>
            <a:endParaRPr lang="en-S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792C9BC-902A-71AE-EF47-91917DBF08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C47A6D0-3412-C4C4-C0FA-DA8E002009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C95F9-F8F9-5B4A-BF3B-32E7657CC304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5000001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A6F5A3-B826-31FE-E4BD-DC767EE96A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417FD9-ADA3-C083-7CC9-A64A7D5FEE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7E33EB1-7B8C-5A5F-C904-369963ED04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D3BEA5-B36C-5272-929E-D5D6C0C105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8BCA0-4444-2247-9867-5C255DEC7E0B}" type="datetimeFigureOut">
              <a:rPr lang="en-SE" smtClean="0"/>
              <a:t>10/11/2024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1D4012-5FF6-DCCF-D651-2BE8D0F6F5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0505A56-89A7-D041-E98C-906092A37F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C95F9-F8F9-5B4A-BF3B-32E7657CC304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8828118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BAB75F-AC92-46E3-39F3-22F084AEF9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02CB14F-D160-B815-2E67-212CA3F611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12B1545-3D47-9BB9-5543-FCE470C18A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434653-9151-853E-E5E8-08158A405B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8BCA0-4444-2247-9867-5C255DEC7E0B}" type="datetimeFigureOut">
              <a:rPr lang="en-SE" smtClean="0"/>
              <a:t>10/11/2024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F18D6D-4FBB-18CA-B19E-4BCC805B8D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0289D8-0AA9-00C0-841A-E9E82D8C2F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C95F9-F8F9-5B4A-BF3B-32E7657CC304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3352506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42C5A64-1C38-2060-3958-1478DBD37C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747A6A-678F-E825-B2F5-62ACE46D2B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F3276B-B5DF-DC57-9971-CBF85353DB9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08BCA0-4444-2247-9867-5C255DEC7E0B}" type="datetimeFigureOut">
              <a:rPr lang="en-SE" smtClean="0"/>
              <a:t>10/11/2024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BD4CD7-2700-D2F3-F636-2513A09502F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E77E64-D596-7D6B-3D9E-77F343AECD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6C95F9-F8F9-5B4A-BF3B-32E7657CC304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8854597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>
            <a:extLst>
              <a:ext uri="{FF2B5EF4-FFF2-40B4-BE49-F238E27FC236}">
                <a16:creationId xmlns:a16="http://schemas.microsoft.com/office/drawing/2014/main" id="{5851BFB6-2BE1-482F-02E9-C29398B2C8DF}"/>
              </a:ext>
            </a:extLst>
          </p:cNvPr>
          <p:cNvGrpSpPr/>
          <p:nvPr/>
        </p:nvGrpSpPr>
        <p:grpSpPr>
          <a:xfrm>
            <a:off x="391921" y="478053"/>
            <a:ext cx="11525168" cy="6082144"/>
            <a:chOff x="391921" y="478053"/>
            <a:chExt cx="11525168" cy="6082144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4CA3A4E9-6B2F-5B56-D615-78FC8AB7F097}"/>
                </a:ext>
              </a:extLst>
            </p:cNvPr>
            <p:cNvSpPr txBox="1"/>
            <p:nvPr/>
          </p:nvSpPr>
          <p:spPr>
            <a:xfrm>
              <a:off x="540259" y="4005652"/>
              <a:ext cx="11261208" cy="25545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SE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. 1. </a:t>
              </a:r>
              <a:r>
                <a:rPr lang="en-US" sz="1600" b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BRET</a:t>
              </a:r>
              <a:r>
                <a:rPr lang="en-US" sz="1600" b="1" baseline="300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1 </a:t>
              </a:r>
              <a:r>
                <a:rPr lang="en-US" sz="1600" b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analysis validates the close proximity of GPR30</a:t>
              </a:r>
              <a:r>
                <a:rPr lang="en-US" sz="1600" b="1" dirty="0">
                  <a:effectLst/>
                  <a:latin typeface="Symbol" pitchFamily="2" charset="2"/>
                  <a:ea typeface="Times New Roman" panose="02020603050405020304" pitchFamily="18" charset="0"/>
                </a:rPr>
                <a:t>D</a:t>
              </a:r>
              <a:r>
                <a:rPr lang="en-US" sz="1600" b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SAV</a:t>
              </a:r>
              <a:r>
                <a:rPr lang="en-US" sz="1600" b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and </a:t>
              </a:r>
              <a:r>
                <a:rPr lang="en-SE" sz="1600" b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  <a:sym typeface="Symbol" pitchFamily="2" charset="2"/>
                </a:rPr>
                <a:t></a:t>
              </a:r>
              <a:r>
                <a:rPr lang="en-US" sz="1600" b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1AR. </a:t>
              </a:r>
              <a:r>
                <a:rPr lang="en-SE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Δ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BRET was determined using HEK293T cells co-expressing GPR30</a:t>
              </a:r>
              <a:r>
                <a:rPr lang="en-US" sz="1600" dirty="0">
                  <a:effectLst/>
                  <a:latin typeface="Symbol" pitchFamily="2" charset="2"/>
                  <a:ea typeface="Times New Roman" panose="02020603050405020304" pitchFamily="18" charset="0"/>
                </a:rPr>
                <a:t>D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SAV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-rLuc and </a:t>
              </a:r>
              <a:r>
                <a:rPr lang="en-SE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  <a:sym typeface="Symbol" pitchFamily="2" charset="2"/>
                </a:rPr>
                <a:t>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1AR-eYFP. GPR30 interaction with RAMP3-eYFP was used as positive control, and GPR30</a:t>
              </a:r>
              <a:r>
                <a:rPr lang="en-US" sz="1600" dirty="0">
                  <a:effectLst/>
                  <a:latin typeface="Symbol" pitchFamily="2" charset="2"/>
                  <a:ea typeface="Times New Roman" panose="02020603050405020304" pitchFamily="18" charset="0"/>
                </a:rPr>
                <a:t>D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SAV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-rLuc interaction with KRAS-Venus was used as negative controls. In panel </a:t>
              </a:r>
              <a:r>
                <a:rPr lang="en-US" sz="1600" b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A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, BRET</a:t>
              </a:r>
              <a:r>
                <a:rPr lang="en-US" sz="1600" baseline="300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1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analysis of GPR30 and RAMP3-YFP is shown, revealing a good interaction (positive control) between GPR30</a:t>
              </a:r>
              <a:r>
                <a:rPr lang="en-US" sz="1600" dirty="0">
                  <a:effectLst/>
                  <a:latin typeface="Symbol" pitchFamily="2" charset="2"/>
                  <a:ea typeface="Times New Roman" panose="02020603050405020304" pitchFamily="18" charset="0"/>
                </a:rPr>
                <a:t>D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SAV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and RAMP3 (</a:t>
              </a:r>
              <a:r>
                <a:rPr lang="en-US" sz="1600" dirty="0" err="1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B</a:t>
              </a:r>
              <a:r>
                <a:rPr lang="en-US" sz="1600" baseline="-25000" dirty="0" err="1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max</a:t>
              </a:r>
              <a:r>
                <a:rPr lang="en-US" sz="1600" baseline="-250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= 0.207, R</a:t>
              </a:r>
              <a:r>
                <a:rPr lang="en-US" sz="1600" baseline="300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2 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hyperbolic = 0.953, R</a:t>
              </a:r>
              <a:r>
                <a:rPr lang="en-US" sz="1600" baseline="300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2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linear = 0.451). In panel </a:t>
              </a:r>
              <a:r>
                <a:rPr lang="en-US" sz="1600" b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B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, BRET</a:t>
              </a:r>
              <a:r>
                <a:rPr lang="en-US" sz="1600" baseline="300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1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analysis of GPR30</a:t>
              </a:r>
              <a:r>
                <a:rPr lang="en-US" sz="1600" dirty="0">
                  <a:effectLst/>
                  <a:latin typeface="Symbol" pitchFamily="2" charset="2"/>
                  <a:ea typeface="Times New Roman" panose="02020603050405020304" pitchFamily="18" charset="0"/>
                </a:rPr>
                <a:t>D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SAV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and </a:t>
              </a:r>
              <a:r>
                <a:rPr lang="en-SE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  <a:sym typeface="Symbol" pitchFamily="2" charset="2"/>
                </a:rPr>
                <a:t>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1AR is shown, revealing a good interaction between the GPR30</a:t>
              </a:r>
              <a:r>
                <a:rPr lang="en-US" sz="1600" dirty="0">
                  <a:effectLst/>
                  <a:latin typeface="Symbol" pitchFamily="2" charset="2"/>
                  <a:ea typeface="Times New Roman" panose="02020603050405020304" pitchFamily="18" charset="0"/>
                </a:rPr>
                <a:t>D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SAV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and </a:t>
              </a:r>
              <a:r>
                <a:rPr lang="en-SE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  <a:sym typeface="Symbol" pitchFamily="2" charset="2"/>
                </a:rPr>
                <a:t>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1AR (</a:t>
              </a:r>
              <a:r>
                <a:rPr lang="en-US" sz="1600" dirty="0" err="1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B</a:t>
              </a:r>
              <a:r>
                <a:rPr lang="en-US" sz="1600" baseline="-25000" dirty="0" err="1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max</a:t>
              </a:r>
              <a:r>
                <a:rPr lang="en-US" sz="1600" baseline="-250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= 0.200, R</a:t>
              </a:r>
              <a:r>
                <a:rPr lang="en-US" sz="1600" baseline="300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2 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hyperbolic = 0.987, R</a:t>
              </a:r>
              <a:r>
                <a:rPr lang="en-US" sz="1600" baseline="300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2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linear = 0.982). In panel </a:t>
              </a:r>
              <a:r>
                <a:rPr lang="en-US" sz="1600" b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C, 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BRET</a:t>
              </a:r>
              <a:r>
                <a:rPr lang="en-US" sz="1600" baseline="300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1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analysis of GPR30</a:t>
              </a:r>
              <a:r>
                <a:rPr lang="en-US" sz="1600" dirty="0">
                  <a:effectLst/>
                  <a:latin typeface="Symbol" pitchFamily="2" charset="2"/>
                  <a:ea typeface="Times New Roman" panose="02020603050405020304" pitchFamily="18" charset="0"/>
                </a:rPr>
                <a:t>D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SAV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and KRAS is shown, revealing no interaction (negative control) (</a:t>
              </a:r>
              <a:r>
                <a:rPr lang="en-US" sz="1600" dirty="0" err="1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B</a:t>
              </a:r>
              <a:r>
                <a:rPr lang="en-US" sz="1600" baseline="-25000" dirty="0" err="1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max</a:t>
              </a:r>
              <a:r>
                <a:rPr lang="en-US" sz="1600" baseline="-250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= </a:t>
              </a:r>
              <a:r>
                <a:rPr lang="en-US" sz="1600" dirty="0" err="1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uncalculable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, R</a:t>
              </a:r>
              <a:r>
                <a:rPr lang="en-US" sz="1600" baseline="300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2 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hyperbolic = 0.719, R</a:t>
              </a:r>
              <a:r>
                <a:rPr lang="en-US" sz="1600" baseline="300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2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linear = 0.782). Data is graphed as the acceptor (-</a:t>
              </a:r>
              <a:r>
                <a:rPr lang="en-US" sz="1600" dirty="0" err="1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eYFP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/Venus)/donor (GPR30</a:t>
              </a:r>
              <a:r>
                <a:rPr lang="en-US" sz="1600" dirty="0">
                  <a:effectLst/>
                  <a:latin typeface="Symbol" pitchFamily="2" charset="2"/>
                  <a:ea typeface="Times New Roman" panose="02020603050405020304" pitchFamily="18" charset="0"/>
                </a:rPr>
                <a:t>D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SAV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-rLuc) ratio (Y-axis) versus total </a:t>
              </a:r>
              <a:r>
                <a:rPr lang="en-US" sz="1600" dirty="0" err="1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eYFP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/Venus fluorescence/luminescence (X-axis), and the curve was fitted utilizing a non-linear regression with one-site specific binding. Data is shown as </a:t>
              </a:r>
              <a:r>
                <a:rPr lang="en-US" sz="1600" dirty="0" err="1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mean±SEM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of three independent experiments.</a:t>
              </a:r>
              <a:endParaRPr lang="en-SE" sz="1600" dirty="0"/>
            </a:p>
          </p:txBody>
        </p: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C750C3A8-D351-C318-6FBD-6FAB038393E0}"/>
                </a:ext>
              </a:extLst>
            </p:cNvPr>
            <p:cNvGrpSpPr/>
            <p:nvPr/>
          </p:nvGrpSpPr>
          <p:grpSpPr>
            <a:xfrm>
              <a:off x="391921" y="478053"/>
              <a:ext cx="11525168" cy="3333472"/>
              <a:chOff x="391921" y="478053"/>
              <a:chExt cx="11525168" cy="3333472"/>
            </a:xfrm>
          </p:grpSpPr>
          <p:grpSp>
            <p:nvGrpSpPr>
              <p:cNvPr id="18" name="Group 17">
                <a:extLst>
                  <a:ext uri="{FF2B5EF4-FFF2-40B4-BE49-F238E27FC236}">
                    <a16:creationId xmlns:a16="http://schemas.microsoft.com/office/drawing/2014/main" id="{761876F7-8CCD-49D1-B6CC-27BA280B974F}"/>
                  </a:ext>
                </a:extLst>
              </p:cNvPr>
              <p:cNvGrpSpPr/>
              <p:nvPr/>
            </p:nvGrpSpPr>
            <p:grpSpPr>
              <a:xfrm>
                <a:off x="391921" y="478053"/>
                <a:ext cx="3975100" cy="3332964"/>
                <a:chOff x="391921" y="478053"/>
                <a:chExt cx="3975100" cy="3332964"/>
              </a:xfrm>
            </p:grpSpPr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958D68EA-D071-084E-1E09-0D226F0E85AD}"/>
                    </a:ext>
                  </a:extLst>
                </p:cNvPr>
                <p:cNvSpPr txBox="1"/>
                <p:nvPr/>
              </p:nvSpPr>
              <p:spPr>
                <a:xfrm>
                  <a:off x="391921" y="478053"/>
                  <a:ext cx="441146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SE" sz="2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.</a:t>
                  </a:r>
                </a:p>
              </p:txBody>
            </p:sp>
            <p:grpSp>
              <p:nvGrpSpPr>
                <p:cNvPr id="17" name="Group 16">
                  <a:extLst>
                    <a:ext uri="{FF2B5EF4-FFF2-40B4-BE49-F238E27FC236}">
                      <a16:creationId xmlns:a16="http://schemas.microsoft.com/office/drawing/2014/main" id="{285B674D-CFA1-932E-35D5-54782F871399}"/>
                    </a:ext>
                  </a:extLst>
                </p:cNvPr>
                <p:cNvGrpSpPr/>
                <p:nvPr/>
              </p:nvGrpSpPr>
              <p:grpSpPr>
                <a:xfrm>
                  <a:off x="391921" y="915417"/>
                  <a:ext cx="3975100" cy="2895600"/>
                  <a:chOff x="391921" y="915417"/>
                  <a:chExt cx="3975100" cy="2895600"/>
                </a:xfrm>
              </p:grpSpPr>
              <p:pic>
                <p:nvPicPr>
                  <p:cNvPr id="2" name="Picture 1">
                    <a:extLst>
                      <a:ext uri="{FF2B5EF4-FFF2-40B4-BE49-F238E27FC236}">
                        <a16:creationId xmlns:a16="http://schemas.microsoft.com/office/drawing/2014/main" id="{B94084FB-1574-BFA0-2383-1AC1553BB14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/>
                  <a:stretch>
                    <a:fillRect/>
                  </a:stretch>
                </p:blipFill>
                <p:spPr>
                  <a:xfrm>
                    <a:off x="391921" y="915417"/>
                    <a:ext cx="3975100" cy="2895600"/>
                  </a:xfrm>
                  <a:prstGeom prst="rect">
                    <a:avLst/>
                  </a:prstGeom>
                </p:spPr>
              </p:pic>
              <p:sp>
                <p:nvSpPr>
                  <p:cNvPr id="5" name="TextBox 4">
                    <a:extLst>
                      <a:ext uri="{FF2B5EF4-FFF2-40B4-BE49-F238E27FC236}">
                        <a16:creationId xmlns:a16="http://schemas.microsoft.com/office/drawing/2014/main" id="{2DB12618-D00C-7785-9D45-B06B5BEE58A6}"/>
                      </a:ext>
                    </a:extLst>
                  </p:cNvPr>
                  <p:cNvSpPr txBox="1"/>
                  <p:nvPr/>
                </p:nvSpPr>
                <p:spPr>
                  <a:xfrm>
                    <a:off x="1998716" y="2203486"/>
                    <a:ext cx="1928733" cy="73866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SE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</a:t>
                    </a:r>
                    <a:r>
                      <a:rPr lang="en-SE" sz="14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SE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Hyperbolic = 0.953</a:t>
                    </a:r>
                  </a:p>
                  <a:p>
                    <a:r>
                      <a:rPr lang="en-SE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</a:t>
                    </a:r>
                    <a:r>
                      <a:rPr lang="en-SE" sz="14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SE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Linear = 0.451</a:t>
                    </a:r>
                  </a:p>
                  <a:p>
                    <a:r>
                      <a:rPr lang="en-SE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max = 0.207</a:t>
                    </a:r>
                  </a:p>
                </p:txBody>
              </p:sp>
            </p:grpSp>
          </p:grpSp>
          <p:grpSp>
            <p:nvGrpSpPr>
              <p:cNvPr id="16" name="Group 15">
                <a:extLst>
                  <a:ext uri="{FF2B5EF4-FFF2-40B4-BE49-F238E27FC236}">
                    <a16:creationId xmlns:a16="http://schemas.microsoft.com/office/drawing/2014/main" id="{1A0251C5-10B6-184B-F227-4615B89B56C4}"/>
                  </a:ext>
                </a:extLst>
              </p:cNvPr>
              <p:cNvGrpSpPr/>
              <p:nvPr/>
            </p:nvGrpSpPr>
            <p:grpSpPr>
              <a:xfrm>
                <a:off x="4234689" y="478053"/>
                <a:ext cx="3873500" cy="3308072"/>
                <a:chOff x="4234689" y="478053"/>
                <a:chExt cx="3873500" cy="3308072"/>
              </a:xfrm>
            </p:grpSpPr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FCF15828-40CF-272F-B563-1E5FBE8B3C75}"/>
                    </a:ext>
                  </a:extLst>
                </p:cNvPr>
                <p:cNvSpPr txBox="1"/>
                <p:nvPr/>
              </p:nvSpPr>
              <p:spPr>
                <a:xfrm>
                  <a:off x="4234689" y="478053"/>
                  <a:ext cx="441146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SE" sz="2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.</a:t>
                  </a:r>
                </a:p>
              </p:txBody>
            </p:sp>
            <p:grpSp>
              <p:nvGrpSpPr>
                <p:cNvPr id="15" name="Group 14">
                  <a:extLst>
                    <a:ext uri="{FF2B5EF4-FFF2-40B4-BE49-F238E27FC236}">
                      <a16:creationId xmlns:a16="http://schemas.microsoft.com/office/drawing/2014/main" id="{E9BC861A-4F44-EBA2-1C30-F42E88453717}"/>
                    </a:ext>
                  </a:extLst>
                </p:cNvPr>
                <p:cNvGrpSpPr/>
                <p:nvPr/>
              </p:nvGrpSpPr>
              <p:grpSpPr>
                <a:xfrm>
                  <a:off x="4234689" y="903225"/>
                  <a:ext cx="3873500" cy="2882900"/>
                  <a:chOff x="4234689" y="903225"/>
                  <a:chExt cx="3873500" cy="2882900"/>
                </a:xfrm>
              </p:grpSpPr>
              <p:pic>
                <p:nvPicPr>
                  <p:cNvPr id="3" name="Picture 2">
                    <a:extLst>
                      <a:ext uri="{FF2B5EF4-FFF2-40B4-BE49-F238E27FC236}">
                        <a16:creationId xmlns:a16="http://schemas.microsoft.com/office/drawing/2014/main" id="{0D5407F9-C7A9-FB38-4E72-86FF83C4084B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/>
                  <a:stretch>
                    <a:fillRect/>
                  </a:stretch>
                </p:blipFill>
                <p:spPr>
                  <a:xfrm>
                    <a:off x="4234689" y="903225"/>
                    <a:ext cx="3873500" cy="2882900"/>
                  </a:xfrm>
                  <a:prstGeom prst="rect">
                    <a:avLst/>
                  </a:prstGeom>
                </p:spPr>
              </p:pic>
              <p:sp>
                <p:nvSpPr>
                  <p:cNvPr id="6" name="TextBox 5">
                    <a:extLst>
                      <a:ext uri="{FF2B5EF4-FFF2-40B4-BE49-F238E27FC236}">
                        <a16:creationId xmlns:a16="http://schemas.microsoft.com/office/drawing/2014/main" id="{9A8E5207-B230-43E8-79B6-AFD25102F835}"/>
                      </a:ext>
                    </a:extLst>
                  </p:cNvPr>
                  <p:cNvSpPr txBox="1"/>
                  <p:nvPr/>
                </p:nvSpPr>
                <p:spPr>
                  <a:xfrm>
                    <a:off x="5896248" y="1618711"/>
                    <a:ext cx="1928733" cy="73866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SE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</a:t>
                    </a:r>
                    <a:r>
                      <a:rPr lang="en-SE" sz="14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SE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Hyperbolic = 0.987</a:t>
                    </a:r>
                  </a:p>
                  <a:p>
                    <a:r>
                      <a:rPr lang="en-SE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</a:t>
                    </a:r>
                    <a:r>
                      <a:rPr lang="en-SE" sz="14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SE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Linear = 0.982</a:t>
                    </a:r>
                  </a:p>
                  <a:p>
                    <a:r>
                      <a:rPr lang="en-SE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max = 0.200</a:t>
                    </a:r>
                  </a:p>
                </p:txBody>
              </p:sp>
            </p:grpSp>
          </p:grpSp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048B22CA-57A8-BCA4-F642-9B74596F1793}"/>
                  </a:ext>
                </a:extLst>
              </p:cNvPr>
              <p:cNvGrpSpPr/>
              <p:nvPr/>
            </p:nvGrpSpPr>
            <p:grpSpPr>
              <a:xfrm>
                <a:off x="7967389" y="478053"/>
                <a:ext cx="3949700" cy="3333472"/>
                <a:chOff x="7967389" y="478053"/>
                <a:chExt cx="3949700" cy="3333472"/>
              </a:xfrm>
            </p:grpSpPr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8D223690-9233-EBDA-7FFF-A11EE2857A5B}"/>
                    </a:ext>
                  </a:extLst>
                </p:cNvPr>
                <p:cNvSpPr txBox="1"/>
                <p:nvPr/>
              </p:nvSpPr>
              <p:spPr>
                <a:xfrm>
                  <a:off x="7967389" y="478053"/>
                  <a:ext cx="441146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SE" sz="2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.</a:t>
                  </a:r>
                </a:p>
              </p:txBody>
            </p:sp>
            <p:grpSp>
              <p:nvGrpSpPr>
                <p:cNvPr id="10" name="Group 9">
                  <a:extLst>
                    <a:ext uri="{FF2B5EF4-FFF2-40B4-BE49-F238E27FC236}">
                      <a16:creationId xmlns:a16="http://schemas.microsoft.com/office/drawing/2014/main" id="{2820765F-9092-3DE0-C2EC-D76203EB1421}"/>
                    </a:ext>
                  </a:extLst>
                </p:cNvPr>
                <p:cNvGrpSpPr/>
                <p:nvPr/>
              </p:nvGrpSpPr>
              <p:grpSpPr>
                <a:xfrm>
                  <a:off x="7967389" y="903225"/>
                  <a:ext cx="3949700" cy="2908300"/>
                  <a:chOff x="7967389" y="903225"/>
                  <a:chExt cx="3949700" cy="2908300"/>
                </a:xfrm>
              </p:grpSpPr>
              <p:pic>
                <p:nvPicPr>
                  <p:cNvPr id="7" name="Picture 6">
                    <a:extLst>
                      <a:ext uri="{FF2B5EF4-FFF2-40B4-BE49-F238E27FC236}">
                        <a16:creationId xmlns:a16="http://schemas.microsoft.com/office/drawing/2014/main" id="{3B8CE568-2469-9274-91B9-624FAB7704E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>
                    <a:off x="7967389" y="903225"/>
                    <a:ext cx="3949700" cy="2908300"/>
                  </a:xfrm>
                  <a:prstGeom prst="rect">
                    <a:avLst/>
                  </a:prstGeom>
                </p:spPr>
              </p:pic>
              <p:sp>
                <p:nvSpPr>
                  <p:cNvPr id="8" name="TextBox 7">
                    <a:extLst>
                      <a:ext uri="{FF2B5EF4-FFF2-40B4-BE49-F238E27FC236}">
                        <a16:creationId xmlns:a16="http://schemas.microsoft.com/office/drawing/2014/main" id="{A665B111-4C56-AC5A-675B-AF9B51E99697}"/>
                      </a:ext>
                    </a:extLst>
                  </p:cNvPr>
                  <p:cNvSpPr txBox="1"/>
                  <p:nvPr/>
                </p:nvSpPr>
                <p:spPr>
                  <a:xfrm>
                    <a:off x="9496616" y="1618711"/>
                    <a:ext cx="1928733" cy="73866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SE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</a:t>
                    </a:r>
                    <a:r>
                      <a:rPr lang="en-SE" sz="14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SE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Hyperbolic = 0.719</a:t>
                    </a:r>
                  </a:p>
                  <a:p>
                    <a:r>
                      <a:rPr lang="en-SE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</a:t>
                    </a:r>
                    <a:r>
                      <a:rPr lang="en-SE" sz="14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SE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Linear = 0.782</a:t>
                    </a:r>
                  </a:p>
                  <a:p>
                    <a:r>
                      <a:rPr lang="en-SE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max = incalculable</a:t>
                    </a:r>
                  </a:p>
                </p:txBody>
              </p:sp>
            </p:grpSp>
          </p:grpSp>
        </p:grpSp>
      </p:grpSp>
    </p:spTree>
    <p:extLst>
      <p:ext uri="{BB962C8B-B14F-4D97-AF65-F5344CB8AC3E}">
        <p14:creationId xmlns:p14="http://schemas.microsoft.com/office/powerpoint/2010/main" val="2332173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5</TotalTime>
  <Words>260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Caron, Kathleen M</cp:lastModifiedBy>
  <cp:revision>5</cp:revision>
  <dcterms:created xsi:type="dcterms:W3CDTF">2023-11-10T17:00:17Z</dcterms:created>
  <dcterms:modified xsi:type="dcterms:W3CDTF">2024-10-11T13:33:25Z</dcterms:modified>
</cp:coreProperties>
</file>